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22D76D0B-ABD6-8252-C09F-027D316A2B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6A25D684-C3E5-BE9D-3EF2-94408FF008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92177F05-1ADE-B53D-550D-990908120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774FA106-9973-6F2E-7ABC-38C83F5DC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10307E70-81C9-8438-8C28-F4782002D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267560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D6CA4F29-0020-26B3-5DA3-D97BA2C893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A1F58400-B912-4456-9B74-71D2CA9524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8FB293C3-8D40-5F59-1DCF-D7D558FAA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281433FE-4814-C709-901B-62E9D3632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BA8B71E7-AF7D-EFFF-C349-723F72D20E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063830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6D95D695-2C01-81CF-C668-7B654B146A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427BB564-585B-A224-BAB4-E2589BC0DA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6FD88A4D-929E-1B82-D165-85010B329B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B6AA331D-483E-C91B-2228-78ACC67CF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90B1A678-336D-7FB7-7BD3-C9F0CE59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24654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FDCCF4CE-63BF-B1F3-AC2A-EABF17E99C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A29705A0-C9C8-DDB1-B952-15E540773E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0739EAAD-D627-204F-5CE9-0C1BF95AE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119BD8CB-B095-D5B7-C5F3-6B01B24DC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0237C58C-8B28-7C76-DB61-7F5F5FBB4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927051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F010C2DC-8173-7D94-3F52-9763C71101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26BEA405-DC3C-0113-628E-754CC94BC4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E10B314E-1547-1279-3BE5-1F228D9D0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4AE17FD7-56A5-01E3-D345-997CE8DB38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BF0B21E6-4822-B007-E2CE-61734F3AC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773043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8A9E746A-1C3B-A4B6-765A-5B2E7FBDA7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63059254-D06E-02C8-A067-9C007E4AC4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3A65F138-DCF2-593E-BEB8-9F05DDBD6A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82280EE4-7DFF-FFAC-C73F-15CC7DC77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FE6A0244-17B4-FD84-FC35-064948A8D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C335B624-4F7C-DE39-3D59-CC65B2396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242022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1400F1BC-9AE2-CDFC-25B5-4DC7390B46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79B0C2E5-4DD9-D700-8823-FE83A761CC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A380A518-0D83-DAE8-5967-851B7C0C89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09D4747A-8BC1-1764-B3B8-F7F5B62F5B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AEB54204-ADC0-A2A5-87F2-8243B333C9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D4C765E9-6475-C9BE-42BE-F3B683AD64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4B6201F6-0E7C-2389-AB7F-232048722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CE263917-7747-D6DE-6E18-DA866A595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436726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59AC0B70-BD41-5ACB-B36A-BDA635846B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7FB7B4FD-D2E7-56E9-5891-BD47478A3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8EC6D1CC-890C-C5B6-98BE-2F9765B3C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72619381-AF77-50FE-319E-A05C6E20D6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801978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8B7EEADB-2059-316A-04E7-447A162927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99B0CCA6-989E-8CC4-5A1C-19851A504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04B02A77-E10A-83B3-A97F-1D3AB7172C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910759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06642F0E-4F24-FA74-5B2E-29B7F86DFA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17265481-E068-7032-C496-51514F5A78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4B0039A2-41CF-0D6A-7CAD-2AECB2F78B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1893C402-FEDC-63D7-EEEF-9BCBEA678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6A918750-A707-DE6C-69B0-C0D426549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7773C114-3F3D-D3F4-8266-9711AD2FE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55186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CBBFDED3-B1D1-EF37-16D9-3F1CB5DBDB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3C6CC159-1BCF-7C22-770E-5986BAF2C0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4EF2E908-7B6E-12F3-6AA0-57B46692A5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5D3B1603-92BF-90FA-283E-06860B59F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A907400A-F9C6-823B-ECF8-5F5C83E4B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3C308E62-CC00-B20C-082D-E0ACFAC24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19757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0596C1D2-5DBE-A4CC-E498-2994474608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968C1D87-2806-7C21-E3A8-692517A645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731DAC3E-FA6E-A0FC-4E68-D4F564F17C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52B7C-F748-48B8-9378-D17CC1647434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F67F4B96-44CD-C507-7982-AA541C1614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39EA24B4-99E2-381C-7AE3-642E445782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A41499-400F-4110-A582-7657631DB9D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879763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9">
            <a:extLst>
              <a:ext uri="{FF2B5EF4-FFF2-40B4-BE49-F238E27FC236}">
                <a16:creationId xmlns:a16="http://schemas.microsoft.com/office/drawing/2014/main" id="{00000000-0008-0000-0000-00000A0000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8722" y="2027207"/>
            <a:ext cx="8404847" cy="2320505"/>
          </a:xfrm>
          <a:prstGeom prst="rect">
            <a:avLst/>
          </a:prstGeom>
          <a:noFill/>
        </p:spPr>
      </p:pic>
      <p:sp>
        <p:nvSpPr>
          <p:cNvPr id="5" name="กล่องข้อความ 4">
            <a:extLst>
              <a:ext uri="{FF2B5EF4-FFF2-40B4-BE49-F238E27FC236}">
                <a16:creationId xmlns:a16="http://schemas.microsoft.com/office/drawing/2014/main" id="{80E86970-110F-D353-F20D-A10725F4F15D}"/>
              </a:ext>
            </a:extLst>
          </p:cNvPr>
          <p:cNvSpPr txBox="1"/>
          <p:nvPr/>
        </p:nvSpPr>
        <p:spPr>
          <a:xfrm>
            <a:off x="1442768" y="4659453"/>
            <a:ext cx="8115300" cy="4778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 Figure S1: Chromatogram in + ESI scan mode of the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Clerodendrum </a:t>
            </a:r>
            <a:r>
              <a:rPr lang="en-US" sz="1200" b="1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erratum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(Linn.) Moon (CSM) drying with hot air oven via, showing the major retention times of detected compound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2709092299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7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8:59:54Z</dcterms:created>
  <dcterms:modified xsi:type="dcterms:W3CDTF">2026-02-22T09:02:04Z</dcterms:modified>
</cp:coreProperties>
</file>